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12192000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84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>
      <p:cViewPr varScale="1">
        <p:scale>
          <a:sx n="66" d="100"/>
          <a:sy n="66" d="100"/>
        </p:scale>
        <p:origin x="3318" y="90"/>
      </p:cViewPr>
      <p:guideLst>
        <p:guide orient="horz" pos="384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7D3E98-2D8E-4796-8BCB-230C9853A8B9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7550B2-B68C-4088-B8AA-182787317A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020745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7D3E98-2D8E-4796-8BCB-230C9853A8B9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7550B2-B68C-4088-B8AA-182787317A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05871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7D3E98-2D8E-4796-8BCB-230C9853A8B9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7550B2-B68C-4088-B8AA-182787317A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208472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7D3E98-2D8E-4796-8BCB-230C9853A8B9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7550B2-B68C-4088-B8AA-182787317A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137298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7D3E98-2D8E-4796-8BCB-230C9853A8B9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7550B2-B68C-4088-B8AA-182787317A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325476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7D3E98-2D8E-4796-8BCB-230C9853A8B9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7550B2-B68C-4088-B8AA-182787317A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139263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7D3E98-2D8E-4796-8BCB-230C9853A8B9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7550B2-B68C-4088-B8AA-182787317A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948965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7D3E98-2D8E-4796-8BCB-230C9853A8B9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7550B2-B68C-4088-B8AA-182787317A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100106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7D3E98-2D8E-4796-8BCB-230C9853A8B9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7550B2-B68C-4088-B8AA-182787317A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176808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7D3E98-2D8E-4796-8BCB-230C9853A8B9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7550B2-B68C-4088-B8AA-182787317A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852977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7D3E98-2D8E-4796-8BCB-230C9853A8B9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7550B2-B68C-4088-B8AA-182787317A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509750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7D3E98-2D8E-4796-8BCB-230C9853A8B9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7550B2-B68C-4088-B8AA-182787317A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10904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0" y="2630905"/>
            <a:ext cx="33522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2 Fig Leave-one-continent out sensitivity analysis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" name="Group 2"/>
          <p:cNvGrpSpPr/>
          <p:nvPr/>
        </p:nvGrpSpPr>
        <p:grpSpPr>
          <a:xfrm>
            <a:off x="0" y="3580829"/>
            <a:ext cx="6800167" cy="4525947"/>
            <a:chOff x="0" y="3580829"/>
            <a:chExt cx="6800167" cy="4525947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6646777"/>
              <a:ext cx="6652705" cy="1459999"/>
            </a:xfrm>
            <a:prstGeom prst="rect">
              <a:avLst/>
            </a:prstGeom>
          </p:spPr>
        </p:pic>
        <p:sp>
          <p:nvSpPr>
            <p:cNvPr id="2" name="TextBox 1"/>
            <p:cNvSpPr txBox="1"/>
            <p:nvPr/>
          </p:nvSpPr>
          <p:spPr>
            <a:xfrm>
              <a:off x="27892" y="6185862"/>
              <a:ext cx="171713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) Metformin vs. insulin</a:t>
              </a:r>
              <a:endParaRPr lang="en-GB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0" y="3580829"/>
              <a:ext cx="168187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) Glyburide vs. insulin</a:t>
              </a:r>
              <a:endParaRPr lang="en-GB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7892" y="4120458"/>
              <a:ext cx="6772275" cy="142875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9382649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87</TotalTime>
  <Words>18</Words>
  <Application>Microsoft Office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Clinical School Computing Service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ne Adkins</dc:creator>
  <cp:lastModifiedBy>Jane Adkins</cp:lastModifiedBy>
  <cp:revision>13</cp:revision>
  <cp:lastPrinted>2019-07-30T07:45:59Z</cp:lastPrinted>
  <dcterms:created xsi:type="dcterms:W3CDTF">2019-07-30T05:09:39Z</dcterms:created>
  <dcterms:modified xsi:type="dcterms:W3CDTF">2020-02-20T07:54:11Z</dcterms:modified>
</cp:coreProperties>
</file>